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307" r:id="rId2"/>
    <p:sldId id="308" r:id="rId3"/>
  </p:sldIdLst>
  <p:sldSz cx="6858000" cy="9906000" type="A4"/>
  <p:notesSz cx="10234613" cy="70993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3" orient="horz" pos="5275" userDrawn="1">
          <p15:clr>
            <a:srgbClr val="A4A3A4"/>
          </p15:clr>
        </p15:guide>
        <p15:guide id="4" pos="261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1CE4E4"/>
    <a:srgbClr val="0000FF"/>
    <a:srgbClr val="FAA1A2"/>
    <a:srgbClr val="6593CA"/>
    <a:srgbClr val="FF168A"/>
    <a:srgbClr val="606060"/>
    <a:srgbClr val="A0A0A4"/>
    <a:srgbClr val="808080"/>
    <a:srgbClr val="FF00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244" autoAdjust="0"/>
    <p:restoredTop sz="96307" autoAdjust="0"/>
  </p:normalViewPr>
  <p:slideViewPr>
    <p:cSldViewPr snapToGrid="0">
      <p:cViewPr varScale="1">
        <p:scale>
          <a:sx n="126" d="100"/>
          <a:sy n="126" d="100"/>
        </p:scale>
        <p:origin x="-4248" y="-120"/>
      </p:cViewPr>
      <p:guideLst>
        <p:guide orient="horz" pos="5275"/>
        <p:guide pos="2614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handoutMaster" Target="handoutMasters/handout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434999" cy="356198"/>
          </a:xfrm>
          <a:prstGeom prst="rect">
            <a:avLst/>
          </a:prstGeom>
        </p:spPr>
        <p:txBody>
          <a:bodyPr vert="horz" lIns="94765" tIns="47382" rIns="94765" bIns="47382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5797247" y="1"/>
            <a:ext cx="4434999" cy="356198"/>
          </a:xfrm>
          <a:prstGeom prst="rect">
            <a:avLst/>
          </a:prstGeom>
        </p:spPr>
        <p:txBody>
          <a:bodyPr vert="horz" lIns="94765" tIns="47382" rIns="94765" bIns="47382" rtlCol="0"/>
          <a:lstStyle>
            <a:lvl1pPr algn="r">
              <a:defRPr sz="1200"/>
            </a:lvl1pPr>
          </a:lstStyle>
          <a:p>
            <a:fld id="{CEED6DD9-7733-43B2-AD7F-45DC97946B08}" type="datetimeFigureOut">
              <a:rPr lang="de-CH" smtClean="0"/>
              <a:t>1/31/22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1" y="6743104"/>
            <a:ext cx="4434999" cy="356197"/>
          </a:xfrm>
          <a:prstGeom prst="rect">
            <a:avLst/>
          </a:prstGeom>
        </p:spPr>
        <p:txBody>
          <a:bodyPr vert="horz" lIns="94765" tIns="47382" rIns="94765" bIns="47382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5797247" y="6743104"/>
            <a:ext cx="4434999" cy="356197"/>
          </a:xfrm>
          <a:prstGeom prst="rect">
            <a:avLst/>
          </a:prstGeom>
        </p:spPr>
        <p:txBody>
          <a:bodyPr vert="horz" lIns="94765" tIns="47382" rIns="94765" bIns="47382" rtlCol="0" anchor="b"/>
          <a:lstStyle>
            <a:lvl1pPr algn="r">
              <a:defRPr sz="1200"/>
            </a:lvl1pPr>
          </a:lstStyle>
          <a:p>
            <a:fld id="{B6686859-A2A5-4A6F-B154-16BB23C61E3A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2860940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434999" cy="356198"/>
          </a:xfrm>
          <a:prstGeom prst="rect">
            <a:avLst/>
          </a:prstGeom>
        </p:spPr>
        <p:txBody>
          <a:bodyPr vert="horz" lIns="94765" tIns="47382" rIns="94765" bIns="47382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5797247" y="1"/>
            <a:ext cx="4434999" cy="356198"/>
          </a:xfrm>
          <a:prstGeom prst="rect">
            <a:avLst/>
          </a:prstGeom>
        </p:spPr>
        <p:txBody>
          <a:bodyPr vert="horz" lIns="94765" tIns="47382" rIns="94765" bIns="47382" rtlCol="0"/>
          <a:lstStyle>
            <a:lvl1pPr algn="r">
              <a:defRPr sz="1200"/>
            </a:lvl1pPr>
          </a:lstStyle>
          <a:p>
            <a:fld id="{DD573BCC-9613-4970-A2C0-E890DC5B9740}" type="datetimeFigureOut">
              <a:rPr lang="de-CH" smtClean="0"/>
              <a:t>1/31/22</a:t>
            </a:fld>
            <a:endParaRPr lang="de-CH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289425" y="887413"/>
            <a:ext cx="1655763" cy="23955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65" tIns="47382" rIns="94765" bIns="47382" rtlCol="0" anchor="ctr"/>
          <a:lstStyle/>
          <a:p>
            <a:endParaRPr lang="de-CH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1023462" y="3416539"/>
            <a:ext cx="8187690" cy="2795350"/>
          </a:xfrm>
          <a:prstGeom prst="rect">
            <a:avLst/>
          </a:prstGeom>
        </p:spPr>
        <p:txBody>
          <a:bodyPr vert="horz" lIns="94765" tIns="47382" rIns="94765" bIns="47382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6743104"/>
            <a:ext cx="4434999" cy="356197"/>
          </a:xfrm>
          <a:prstGeom prst="rect">
            <a:avLst/>
          </a:prstGeom>
        </p:spPr>
        <p:txBody>
          <a:bodyPr vert="horz" lIns="94765" tIns="47382" rIns="94765" bIns="47382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5797247" y="6743104"/>
            <a:ext cx="4434999" cy="356197"/>
          </a:xfrm>
          <a:prstGeom prst="rect">
            <a:avLst/>
          </a:prstGeom>
        </p:spPr>
        <p:txBody>
          <a:bodyPr vert="horz" lIns="94765" tIns="47382" rIns="94765" bIns="47382" rtlCol="0" anchor="b"/>
          <a:lstStyle>
            <a:lvl1pPr algn="r">
              <a:defRPr sz="1200"/>
            </a:lvl1pPr>
          </a:lstStyle>
          <a:p>
            <a:fld id="{88771E9C-7CCD-4D4D-9261-74B94E9B7B9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946149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1/31/2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44136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1/31/2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59995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1/31/2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75180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1/31/2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54724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1/31/2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17833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1/31/22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451377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1/31/22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58685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1/31/22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03788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1/31/22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19855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1/31/22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22300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1/31/22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116345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4E1851-AE6C-4E47-B48E-BBF48DCEFD92}" type="datetimeFigureOut">
              <a:rPr lang="de-CH" smtClean="0"/>
              <a:t>1/31/2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6535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="" xmlns:a16="http://schemas.microsoft.com/office/drawing/2014/main" id="{4DCC610A-634C-41FB-97B8-597FC65219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9420438"/>
              </p:ext>
            </p:extLst>
          </p:nvPr>
        </p:nvGraphicFramePr>
        <p:xfrm>
          <a:off x="454051" y="699536"/>
          <a:ext cx="5949898" cy="22250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63500">
                  <a:extLst>
                    <a:ext uri="{9D8B030D-6E8A-4147-A177-3AD203B41FA5}">
                      <a16:colId xmlns="" xmlns:a16="http://schemas.microsoft.com/office/drawing/2014/main" val="3836980583"/>
                    </a:ext>
                  </a:extLst>
                </a:gridCol>
                <a:gridCol w="553720">
                  <a:extLst>
                    <a:ext uri="{9D8B030D-6E8A-4147-A177-3AD203B41FA5}">
                      <a16:colId xmlns="" xmlns:a16="http://schemas.microsoft.com/office/drawing/2014/main" val="2826008736"/>
                    </a:ext>
                  </a:extLst>
                </a:gridCol>
                <a:gridCol w="472440">
                  <a:extLst>
                    <a:ext uri="{9D8B030D-6E8A-4147-A177-3AD203B41FA5}">
                      <a16:colId xmlns="" xmlns:a16="http://schemas.microsoft.com/office/drawing/2014/main" val="391207663"/>
                    </a:ext>
                  </a:extLst>
                </a:gridCol>
                <a:gridCol w="1026160">
                  <a:extLst>
                    <a:ext uri="{9D8B030D-6E8A-4147-A177-3AD203B41FA5}">
                      <a16:colId xmlns="" xmlns:a16="http://schemas.microsoft.com/office/drawing/2014/main" val="2080142268"/>
                    </a:ext>
                  </a:extLst>
                </a:gridCol>
                <a:gridCol w="467360">
                  <a:extLst>
                    <a:ext uri="{9D8B030D-6E8A-4147-A177-3AD203B41FA5}">
                      <a16:colId xmlns="" xmlns:a16="http://schemas.microsoft.com/office/drawing/2014/main" val="1924395865"/>
                    </a:ext>
                  </a:extLst>
                </a:gridCol>
                <a:gridCol w="690312">
                  <a:extLst>
                    <a:ext uri="{9D8B030D-6E8A-4147-A177-3AD203B41FA5}">
                      <a16:colId xmlns="" xmlns:a16="http://schemas.microsoft.com/office/drawing/2014/main" val="2845463426"/>
                    </a:ext>
                  </a:extLst>
                </a:gridCol>
                <a:gridCol w="2276406">
                  <a:extLst>
                    <a:ext uri="{9D8B030D-6E8A-4147-A177-3AD203B41FA5}">
                      <a16:colId xmlns="" xmlns:a16="http://schemas.microsoft.com/office/drawing/2014/main" val="1614654810"/>
                    </a:ext>
                  </a:extLst>
                </a:gridCol>
              </a:tblGrid>
              <a:tr h="25151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C-terminal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NA name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gRNA sequence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M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ientation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u="none" strike="noStrike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ODN</a:t>
                      </a:r>
                      <a:r>
                        <a:rPr lang="en-US" sz="800" b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NA template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296373718"/>
                  </a:ext>
                </a:extLst>
              </a:tr>
              <a:tr h="25151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K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K3-C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GTGTCTGAGGAAACCTC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GGGTCCGGCAAAGGTGCGGCCCTGGTCACCGCTGTTGCCTGCCGCCTTGCGCAGTTGACTCGTGTCGTGAGCGGCTGGCGGCTGTTCAAGAAGATTAGCTGAGGAAACCTCCACGCTGAGGAGGTCTCCGCCGCAGCCTTGCTGGAGCCGGGTCGGGGTCTGCCTGTTTCCCAGCCAGGCC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913035587"/>
                  </a:ext>
                </a:extLst>
              </a:tr>
              <a:tr h="25151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K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K2-C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AGAACCCCTGAAATCGG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CAGTCAGAGGATGGCAGCGGGAAGGGGGCGGCGCTCATCACTGCTGTGGCCTGCCGCATCCGTGAGGCTGGACAGCGAGTGAGCGGCTGGCGGCTGTTCAAGAAGATTAGCTAGATCCCCTGAAATCGAAAGCGACTTCCTCTTTCTCTCCTTCTTCCCTGTTTTAAATTATAAGATGTCATCCCCTTGTG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299525912"/>
                  </a:ext>
                </a:extLst>
              </a:tr>
            </a:tbl>
          </a:graphicData>
        </a:graphic>
      </p:graphicFrame>
      <p:sp>
        <p:nvSpPr>
          <p:cNvPr id="5" name="Textfeld 26">
            <a:extLst>
              <a:ext uri="{FF2B5EF4-FFF2-40B4-BE49-F238E27FC236}">
                <a16:creationId xmlns="" xmlns:a16="http://schemas.microsoft.com/office/drawing/2014/main" id="{028DD568-85EA-494E-83D1-4A9366A25348}"/>
              </a:ext>
            </a:extLst>
          </p:cNvPr>
          <p:cNvSpPr txBox="1"/>
          <p:nvPr/>
        </p:nvSpPr>
        <p:spPr>
          <a:xfrm>
            <a:off x="454051" y="397137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Table 1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71927" y="2812149"/>
            <a:ext cx="603250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>
                <a:latin typeface="Arial"/>
                <a:cs typeface="Arial"/>
              </a:rPr>
              <a:t> </a:t>
            </a:r>
            <a:endParaRPr lang="x-none" sz="900">
              <a:latin typeface="Arial"/>
              <a:cs typeface="Arial"/>
            </a:endParaRPr>
          </a:p>
          <a:p>
            <a:pPr algn="just"/>
            <a:r>
              <a:rPr lang="en-US" sz="900" b="1">
                <a:latin typeface="Arial"/>
                <a:cs typeface="Arial"/>
              </a:rPr>
              <a:t>Table S1 </a:t>
            </a:r>
            <a:r>
              <a:rPr lang="en-US" sz="900">
                <a:latin typeface="Arial"/>
                <a:cs typeface="Arial"/>
              </a:rPr>
              <a:t>Sequences of sgRNA and ssODN DNA template for generation of HiBiT-tagged HK2 and HK3 cell lines. </a:t>
            </a:r>
            <a:endParaRPr lang="x-none" sz="900">
              <a:latin typeface="Arial"/>
              <a:cs typeface="Arial"/>
            </a:endParaRPr>
          </a:p>
          <a:p>
            <a:pPr algn="just"/>
            <a:endParaRPr lang="x-none" sz="90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888958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6">
            <a:extLst>
              <a:ext uri="{FF2B5EF4-FFF2-40B4-BE49-F238E27FC236}">
                <a16:creationId xmlns="" xmlns:a16="http://schemas.microsoft.com/office/drawing/2014/main" id="{8167FEFF-293F-4935-863C-C74C102BB1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27452527"/>
              </p:ext>
            </p:extLst>
          </p:nvPr>
        </p:nvGraphicFramePr>
        <p:xfrm>
          <a:off x="454047" y="769001"/>
          <a:ext cx="5925749" cy="244927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695821">
                  <a:extLst>
                    <a:ext uri="{9D8B030D-6E8A-4147-A177-3AD203B41FA5}">
                      <a16:colId xmlns="" xmlns:a16="http://schemas.microsoft.com/office/drawing/2014/main" val="485282514"/>
                    </a:ext>
                  </a:extLst>
                </a:gridCol>
                <a:gridCol w="1568992">
                  <a:extLst>
                    <a:ext uri="{9D8B030D-6E8A-4147-A177-3AD203B41FA5}">
                      <a16:colId xmlns="" xmlns:a16="http://schemas.microsoft.com/office/drawing/2014/main" val="1042790571"/>
                    </a:ext>
                  </a:extLst>
                </a:gridCol>
                <a:gridCol w="915234">
                  <a:extLst>
                    <a:ext uri="{9D8B030D-6E8A-4147-A177-3AD203B41FA5}">
                      <a16:colId xmlns="" xmlns:a16="http://schemas.microsoft.com/office/drawing/2014/main" val="1335531525"/>
                    </a:ext>
                  </a:extLst>
                </a:gridCol>
                <a:gridCol w="915234">
                  <a:extLst>
                    <a:ext uri="{9D8B030D-6E8A-4147-A177-3AD203B41FA5}">
                      <a16:colId xmlns="" xmlns:a16="http://schemas.microsoft.com/office/drawing/2014/main" val="1195014795"/>
                    </a:ext>
                  </a:extLst>
                </a:gridCol>
                <a:gridCol w="915234">
                  <a:extLst>
                    <a:ext uri="{9D8B030D-6E8A-4147-A177-3AD203B41FA5}">
                      <a16:colId xmlns="" xmlns:a16="http://schemas.microsoft.com/office/drawing/2014/main" val="1742328055"/>
                    </a:ext>
                  </a:extLst>
                </a:gridCol>
                <a:gridCol w="915234">
                  <a:extLst>
                    <a:ext uri="{9D8B030D-6E8A-4147-A177-3AD203B41FA5}">
                      <a16:colId xmlns="" xmlns:a16="http://schemas.microsoft.com/office/drawing/2014/main" val="91512409"/>
                    </a:ext>
                  </a:extLst>
                </a:gridCol>
              </a:tblGrid>
              <a:tr h="240565"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ss </a:t>
                      </a:r>
                      <a:r>
                        <a:rPr lang="de-CH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trometry</a:t>
                      </a:r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CH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tral</a:t>
                      </a:r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CH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CH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718740216"/>
                  </a:ext>
                </a:extLst>
              </a:tr>
              <a:tr h="240565">
                <a:tc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K2</a:t>
                      </a:r>
                      <a:r>
                        <a:rPr lang="de-CH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de-CH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K3</a:t>
                      </a:r>
                      <a:endParaRPr 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2586556158"/>
                  </a:ext>
                </a:extLst>
              </a:tr>
              <a:tr h="240565">
                <a:tc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D</a:t>
                      </a:r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ay 4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D</a:t>
                      </a:r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ay 4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304765532"/>
                  </a:ext>
                </a:extLst>
              </a:tr>
              <a:tr h="240565">
                <a:tc rowSpan="3">
                  <a:txBody>
                    <a:bodyPr/>
                    <a:lstStyle/>
                    <a:p>
                      <a:pPr algn="ctr"/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L6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vert="vert270" anchor="ctr"/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5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448905692"/>
                  </a:ext>
                </a:extLst>
              </a:tr>
              <a:tr h="240565">
                <a:tc vMerge="1"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K2 KO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489951809"/>
                  </a:ext>
                </a:extLst>
              </a:tr>
              <a:tr h="240565">
                <a:tc vMerge="1"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K3 KO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893658857"/>
                  </a:ext>
                </a:extLst>
              </a:tr>
              <a:tr h="254710">
                <a:tc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RA Day 4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RA Day 4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027150720"/>
                  </a:ext>
                </a:extLst>
              </a:tr>
              <a:tr h="240565">
                <a:tc rowSpan="3">
                  <a:txBody>
                    <a:bodyPr/>
                    <a:lstStyle/>
                    <a:p>
                      <a:pPr algn="ctr"/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4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vert="vert270" anchor="ctr"/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5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871198900"/>
                  </a:ext>
                </a:extLst>
              </a:tr>
              <a:tr h="240565">
                <a:tc vMerge="1"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K2 KO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5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3412098125"/>
                  </a:ext>
                </a:extLst>
              </a:tr>
              <a:tr h="240565">
                <a:tc vMerge="1"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K3 KO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5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e-CH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3717803717"/>
                  </a:ext>
                </a:extLst>
              </a:tr>
            </a:tbl>
          </a:graphicData>
        </a:graphic>
      </p:graphicFrame>
      <p:sp>
        <p:nvSpPr>
          <p:cNvPr id="7" name="Textfeld 26">
            <a:extLst>
              <a:ext uri="{FF2B5EF4-FFF2-40B4-BE49-F238E27FC236}">
                <a16:creationId xmlns="" xmlns:a16="http://schemas.microsoft.com/office/drawing/2014/main" id="{F4BEB502-5142-479F-9D7A-4CFB1806CD62}"/>
              </a:ext>
            </a:extLst>
          </p:cNvPr>
          <p:cNvSpPr txBox="1"/>
          <p:nvPr/>
        </p:nvSpPr>
        <p:spPr>
          <a:xfrm>
            <a:off x="454047" y="466601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Table 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72411" y="2972381"/>
            <a:ext cx="56864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 </a:t>
            </a:r>
            <a:endParaRPr lang="x-none" sz="900">
              <a:latin typeface="Arial"/>
              <a:cs typeface="Arial"/>
            </a:endParaRPr>
          </a:p>
          <a:p>
            <a:r>
              <a:rPr lang="en-US" sz="900">
                <a:latin typeface="Arial"/>
                <a:cs typeface="Arial"/>
              </a:rPr>
              <a:t> </a:t>
            </a:r>
            <a:endParaRPr lang="x-none" sz="900">
              <a:latin typeface="Arial"/>
              <a:cs typeface="Arial"/>
            </a:endParaRPr>
          </a:p>
          <a:p>
            <a:r>
              <a:rPr lang="en-US" sz="900" b="1">
                <a:latin typeface="Arial"/>
                <a:cs typeface="Arial"/>
              </a:rPr>
              <a:t>Table S2</a:t>
            </a:r>
            <a:r>
              <a:rPr lang="en-US" sz="900">
                <a:latin typeface="Arial"/>
                <a:cs typeface="Arial"/>
              </a:rPr>
              <a:t> Mass spectrometry spectral counts in HL60 and NB4 cell lines for confirmation of HK2/3 knockout.</a:t>
            </a:r>
            <a:endParaRPr lang="x-none" sz="900">
              <a:latin typeface="Arial"/>
              <a:cs typeface="Arial"/>
            </a:endParaRPr>
          </a:p>
          <a:p>
            <a:endParaRPr lang="en-US" sz="90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647179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652</TotalTime>
  <Words>102</Words>
  <Application>Microsoft Macintosh PowerPoint</Application>
  <PresentationFormat>A4 Paper (210x297 mm)</PresentationFormat>
  <Paragraphs>7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UniB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umbert, Magali (PATHOLOGY)</dc:creator>
  <cp:lastModifiedBy>Mario Tschan</cp:lastModifiedBy>
  <cp:revision>1427</cp:revision>
  <cp:lastPrinted>2018-11-07T09:37:40Z</cp:lastPrinted>
  <dcterms:created xsi:type="dcterms:W3CDTF">2016-04-05T11:57:06Z</dcterms:created>
  <dcterms:modified xsi:type="dcterms:W3CDTF">2022-01-31T15:24:50Z</dcterms:modified>
</cp:coreProperties>
</file>